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965F0F-A5F6-4C49-A0E2-7945729925B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3F0D422-B5CA-4F59-851E-DBE20A0247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3ED94DB-EC8C-45D8-B334-6C8F7953BA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4A18A-6011-4CB6-9FE8-09D9A70E5AEB}" type="datetimeFigureOut">
              <a:rPr lang="zh-CN" altLang="en-US" smtClean="0"/>
              <a:t>2022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B4756F2-5E9F-4CAC-8672-5A0943BD9A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E8BC6C8-D300-4C2B-9C7E-E040A4E763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DC27B-A1DC-4F3A-B053-BE7B79E6A3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2926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2CD266-916D-4F2A-9926-FB671CB628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6BBF7A0-20E8-4890-AEF9-48509DE4A9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1BCF897-B3E5-4B49-BF14-3F0B7FE08D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4A18A-6011-4CB6-9FE8-09D9A70E5AEB}" type="datetimeFigureOut">
              <a:rPr lang="zh-CN" altLang="en-US" smtClean="0"/>
              <a:t>2022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71482B6-2C67-4CCC-A80F-C9EDFB1F83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518A54D-3842-4A60-801E-B6859DAAC0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DC27B-A1DC-4F3A-B053-BE7B79E6A3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486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13DCCB1-782A-444C-895C-2B8A8F8673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676B922-B2B6-4BD4-A9E9-DD40206345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FC095E6-1F3E-4925-85FE-A4BF00A0A9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4A18A-6011-4CB6-9FE8-09D9A70E5AEB}" type="datetimeFigureOut">
              <a:rPr lang="zh-CN" altLang="en-US" smtClean="0"/>
              <a:t>2022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D2318BD-AB9A-46A8-AFB7-D912DE478F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5A3B2C4-4C02-4E5E-B053-CB62AE0498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DC27B-A1DC-4F3A-B053-BE7B79E6A3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61508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AC19BF5-AFE7-405C-8B19-314BF4B087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C59D567-1FF3-4448-B286-3195F67EFE4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693AD12-2138-4634-AA59-E035941FB9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4A18A-6011-4CB6-9FE8-09D9A70E5AEB}" type="datetimeFigureOut">
              <a:rPr lang="zh-CN" altLang="en-US" smtClean="0"/>
              <a:t>2022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C07F9B2-CBD2-4763-94A8-9DB77A38FA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3F3AA34-863E-4F25-AC68-CA5871605C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DC27B-A1DC-4F3A-B053-BE7B79E6A3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85087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DE6691-1B79-4D06-816A-82982C335A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7A3596E-5EF9-430B-B03B-1B37DDB612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24AF3E0-26D6-4B3B-AAF2-A507A8289F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4A18A-6011-4CB6-9FE8-09D9A70E5AEB}" type="datetimeFigureOut">
              <a:rPr lang="zh-CN" altLang="en-US" smtClean="0"/>
              <a:t>2022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3B0C40C-42F9-4AF9-B2B9-005F44D186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98CF82E-D9D3-4E70-8363-B16A2C5EB3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DC27B-A1DC-4F3A-B053-BE7B79E6A3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9050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9EE5BA8-81D8-4945-BF54-BF8B021F25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9D57DCA-317C-4611-90D1-7F5C04A2C90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2C323DA-C344-42F5-83CE-631AE435D0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4CAA80D-372A-454F-86A4-74C138C371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4A18A-6011-4CB6-9FE8-09D9A70E5AEB}" type="datetimeFigureOut">
              <a:rPr lang="zh-CN" altLang="en-US" smtClean="0"/>
              <a:t>2022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B6C04AB-EA01-4B5F-A018-801C37F457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A9AFBEB-5D02-4CA6-A999-4C9F06C497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DC27B-A1DC-4F3A-B053-BE7B79E6A3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82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27B89C-B5C7-40A1-8C59-1FAA2462AB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9EF2B09-2E13-47E1-AAB1-FCD3F02D06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637579B-A1B8-4480-A8C0-29BA999F8E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3086A82-4C76-4414-A300-7B5D4FFCE5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A5D6627-B851-43CC-AE22-89306DA1E7C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5F1FFAE-EAB6-4E76-A61E-A88D642551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4A18A-6011-4CB6-9FE8-09D9A70E5AEB}" type="datetimeFigureOut">
              <a:rPr lang="zh-CN" altLang="en-US" smtClean="0"/>
              <a:t>2022/3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6F6237B-714E-4D9E-8DFC-3F585060D9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03B451C-FB9C-45CE-A136-22C19122FB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DC27B-A1DC-4F3A-B053-BE7B79E6A3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79413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6399E7-4160-4559-AED4-A579711483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ABD6F23-7566-45B5-B1B0-821740044C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4A18A-6011-4CB6-9FE8-09D9A70E5AEB}" type="datetimeFigureOut">
              <a:rPr lang="zh-CN" altLang="en-US" smtClean="0"/>
              <a:t>2022/3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6703F48-678A-410A-9CBD-04548480BA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4E327D2-74D7-4E40-BE92-6CBB2E52F6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DC27B-A1DC-4F3A-B053-BE7B79E6A3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32102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02085C3-8C0C-4EB2-A4C0-FADE2A0D0B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4A18A-6011-4CB6-9FE8-09D9A70E5AEB}" type="datetimeFigureOut">
              <a:rPr lang="zh-CN" altLang="en-US" smtClean="0"/>
              <a:t>2022/3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DA40C1D-E37F-4CBB-A6A9-22099EF73A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FCAACE0-691A-47C0-9F9C-02ED63B71D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DC27B-A1DC-4F3A-B053-BE7B79E6A3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0711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C4A3DD-6545-4F5C-9136-160B3AC972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25C8F6B-FEC2-4543-A5B0-442F50FD2A0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167003C-D8E3-4FB1-A15E-9ADB008875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9A937F3-0AA6-4D3B-A13D-C912FD2BB1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4A18A-6011-4CB6-9FE8-09D9A70E5AEB}" type="datetimeFigureOut">
              <a:rPr lang="zh-CN" altLang="en-US" smtClean="0"/>
              <a:t>2022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45B39EC-3710-421D-9A72-AB802C13F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B7D4B42-A185-411A-B98D-6E7393A3C7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DC27B-A1DC-4F3A-B053-BE7B79E6A3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93568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FEE93CD-8443-45BF-BF6B-DF36454CCF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ECB17B9-5305-4406-8187-83EFA876DC3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902EC5E-DC2E-4AD0-A618-D27ABB8F68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736FB34-93A4-479F-990F-24A365CF84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4A18A-6011-4CB6-9FE8-09D9A70E5AEB}" type="datetimeFigureOut">
              <a:rPr lang="zh-CN" altLang="en-US" smtClean="0"/>
              <a:t>2022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B847F0E-0CB8-4BDC-95C0-EE19F12E24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D7DB166-951B-4DEB-A236-716AF2BE02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DC27B-A1DC-4F3A-B053-BE7B79E6A3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4443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1259CD5-81B9-46A0-93A6-E50BDCFAAE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86C56F1-299D-4302-AAA9-84CAEA6453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17B6F48-9C37-4085-8C62-138A0812FE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54A18A-6011-4CB6-9FE8-09D9A70E5AEB}" type="datetimeFigureOut">
              <a:rPr lang="zh-CN" altLang="en-US" smtClean="0"/>
              <a:t>2022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E06FD22-41F6-4D46-8E4F-CB5D3742A8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AA6C3C6-AB7B-47DD-9C09-68A85F7C68F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1DC27B-A1DC-4F3A-B053-BE7B79E6A3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30513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4">
            <a:extLst>
              <a:ext uri="{FF2B5EF4-FFF2-40B4-BE49-F238E27FC236}">
                <a16:creationId xmlns:a16="http://schemas.microsoft.com/office/drawing/2014/main" id="{83410B3C-A86D-42D9-9F6B-C8CC9319BD2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1645" y="840673"/>
            <a:ext cx="5597514" cy="5440575"/>
          </a:xfr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CC9C3D68-CBA4-4F70-BA9E-8941B2353F6B}"/>
              </a:ext>
            </a:extLst>
          </p:cNvPr>
          <p:cNvSpPr txBox="1"/>
          <p:nvPr/>
        </p:nvSpPr>
        <p:spPr>
          <a:xfrm>
            <a:off x="2626369" y="471341"/>
            <a:ext cx="7268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1. PRISMA Flowchart of search strategy and study selection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9034254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C438E50-DCA2-4BE2-9A40-B25A33466C1C}"/>
              </a:ext>
            </a:extLst>
          </p:cNvPr>
          <p:cNvSpPr txBox="1"/>
          <p:nvPr/>
        </p:nvSpPr>
        <p:spPr>
          <a:xfrm>
            <a:off x="2461967" y="612742"/>
            <a:ext cx="7268066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1200"/>
              </a:spcAft>
            </a:pPr>
            <a:r>
              <a:rPr lang="en-US" altLang="zh-CN" sz="24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upplementary material</a:t>
            </a:r>
          </a:p>
          <a:p>
            <a:pPr algn="ctr"/>
            <a:r>
              <a:rPr lang="en-US" altLang="zh-CN" sz="18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ure 1B. Forest plots for the meta-analyses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: </a:t>
            </a:r>
            <a:r>
              <a:rPr lang="en-US" altLang="zh-CN" sz="18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pCR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of consolidation.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9C47C7FA-3C97-4D7B-950C-EEDB7A281F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1637" y="1752600"/>
            <a:ext cx="8848725" cy="335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21778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C438E50-DCA2-4BE2-9A40-B25A33466C1C}"/>
              </a:ext>
            </a:extLst>
          </p:cNvPr>
          <p:cNvSpPr txBox="1"/>
          <p:nvPr/>
        </p:nvSpPr>
        <p:spPr>
          <a:xfrm>
            <a:off x="2461967" y="612742"/>
            <a:ext cx="7268066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1200"/>
              </a:spcAft>
            </a:pPr>
            <a:r>
              <a:rPr lang="en-US" altLang="zh-CN" sz="24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upplementary material</a:t>
            </a:r>
          </a:p>
          <a:p>
            <a:pPr algn="ctr"/>
            <a:r>
              <a:rPr lang="en-US" altLang="zh-CN" sz="18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ure 2A.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orest plots for the meta-analyses: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OS of induction ;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: OS of consolidation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ctr"/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2E0A782B-98F6-4A02-98A6-BF7BE86641E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8192" y="1985815"/>
            <a:ext cx="9381488" cy="23537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289409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C438E50-DCA2-4BE2-9A40-B25A33466C1C}"/>
              </a:ext>
            </a:extLst>
          </p:cNvPr>
          <p:cNvSpPr txBox="1"/>
          <p:nvPr/>
        </p:nvSpPr>
        <p:spPr>
          <a:xfrm>
            <a:off x="2461967" y="612742"/>
            <a:ext cx="7268066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1200"/>
              </a:spcAft>
            </a:pPr>
            <a:r>
              <a:rPr lang="en-US" altLang="zh-CN" sz="24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upplementary material</a:t>
            </a:r>
          </a:p>
          <a:p>
            <a:pPr algn="ctr"/>
            <a:r>
              <a:rPr lang="en-US" altLang="zh-CN" sz="18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ure 2B. 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orest plots for the meta-analyses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: OS of consolidation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ctr"/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10D1C791-6D5A-49D5-9EA5-702FC14D71F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8272" y="1782293"/>
            <a:ext cx="9115455" cy="26577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78606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2171CD5-49A7-4967-9268-57BC90786B5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9237" y="1066800"/>
            <a:ext cx="9153525" cy="472440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5C438E50-DCA2-4BE2-9A40-B25A33466C1C}"/>
              </a:ext>
            </a:extLst>
          </p:cNvPr>
          <p:cNvSpPr txBox="1"/>
          <p:nvPr/>
        </p:nvSpPr>
        <p:spPr>
          <a:xfrm>
            <a:off x="2626369" y="471341"/>
            <a:ext cx="7268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2A. Forest plots for the meta-analyses: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CR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7492901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C438E50-DCA2-4BE2-9A40-B25A33466C1C}"/>
              </a:ext>
            </a:extLst>
          </p:cNvPr>
          <p:cNvSpPr txBox="1"/>
          <p:nvPr/>
        </p:nvSpPr>
        <p:spPr>
          <a:xfrm>
            <a:off x="2626369" y="471341"/>
            <a:ext cx="7268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2B. Forest plots for the meta-analyses: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R0 resection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69F6BEB-2DEA-4094-8CC1-1DBC3820055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7812" y="1127289"/>
            <a:ext cx="9096375" cy="396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79109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C438E50-DCA2-4BE2-9A40-B25A33466C1C}"/>
              </a:ext>
            </a:extLst>
          </p:cNvPr>
          <p:cNvSpPr txBox="1"/>
          <p:nvPr/>
        </p:nvSpPr>
        <p:spPr>
          <a:xfrm>
            <a:off x="3248538" y="772998"/>
            <a:ext cx="7268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3A. Forest plots for the meta-analyses: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OS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36286E7C-9CB4-460D-9A33-BA3CEB7C9AF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7900" y="1611867"/>
            <a:ext cx="9038704" cy="32789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68005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C438E50-DCA2-4BE2-9A40-B25A33466C1C}"/>
              </a:ext>
            </a:extLst>
          </p:cNvPr>
          <p:cNvSpPr txBox="1"/>
          <p:nvPr/>
        </p:nvSpPr>
        <p:spPr>
          <a:xfrm>
            <a:off x="3503062" y="1093510"/>
            <a:ext cx="7268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3B. Forest plots for the meta-analyses: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FS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E784445-7115-45E1-85E4-07BB5A6BC0C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1656" y="1901416"/>
            <a:ext cx="9129472" cy="32550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42519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C438E50-DCA2-4BE2-9A40-B25A33466C1C}"/>
              </a:ext>
            </a:extLst>
          </p:cNvPr>
          <p:cNvSpPr txBox="1"/>
          <p:nvPr/>
        </p:nvSpPr>
        <p:spPr>
          <a:xfrm>
            <a:off x="3380513" y="1159498"/>
            <a:ext cx="5282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3C. Forest plots for the meta-analyses: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LRFS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E41F151-7013-4CFC-81B1-F4C38124559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2380" y="1910499"/>
            <a:ext cx="9887240" cy="24541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262350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C438E50-DCA2-4BE2-9A40-B25A33466C1C}"/>
              </a:ext>
            </a:extLst>
          </p:cNvPr>
          <p:cNvSpPr txBox="1"/>
          <p:nvPr/>
        </p:nvSpPr>
        <p:spPr>
          <a:xfrm>
            <a:off x="3248538" y="1150071"/>
            <a:ext cx="7268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3D. Forest plots for the meta-analyses: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MFS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2D0DF56D-F994-4B96-96DE-9EB68F5C2F1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1145" y="1811892"/>
            <a:ext cx="9365459" cy="29281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748996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C438E50-DCA2-4BE2-9A40-B25A33466C1C}"/>
              </a:ext>
            </a:extLst>
          </p:cNvPr>
          <p:cNvSpPr txBox="1"/>
          <p:nvPr/>
        </p:nvSpPr>
        <p:spPr>
          <a:xfrm>
            <a:off x="2461967" y="697584"/>
            <a:ext cx="72680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4. Funnel plot of publication bias in the meta-analysis. </a:t>
            </a:r>
          </a:p>
          <a:p>
            <a:pPr algn="ctr"/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A: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CR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; B: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R0 resection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; C: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OS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; D: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FS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; E: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LRFS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; F: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MFS.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98F0E1D3-8426-4F92-B928-1B2D4CB2D11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8646" y="1433345"/>
            <a:ext cx="7948425" cy="46516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910758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C438E50-DCA2-4BE2-9A40-B25A33466C1C}"/>
              </a:ext>
            </a:extLst>
          </p:cNvPr>
          <p:cNvSpPr txBox="1"/>
          <p:nvPr/>
        </p:nvSpPr>
        <p:spPr>
          <a:xfrm>
            <a:off x="2461967" y="612742"/>
            <a:ext cx="7268066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1200"/>
              </a:spcAft>
            </a:pPr>
            <a:r>
              <a:rPr lang="en-US" altLang="zh-CN" sz="24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upplementary material</a:t>
            </a:r>
          </a:p>
          <a:p>
            <a:pPr algn="ctr"/>
            <a:r>
              <a:rPr lang="en-US" altLang="zh-CN" sz="18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ure 1A. Forest plots for the meta-analyses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: </a:t>
            </a:r>
            <a:r>
              <a:rPr lang="en-US" altLang="zh-CN" sz="18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pCR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of induction.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B3BB17C-55D4-4310-A526-D0089E2D171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3525" y="1981200"/>
            <a:ext cx="9124950" cy="2895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32585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180</Words>
  <Application>Microsoft Office PowerPoint</Application>
  <PresentationFormat>宽屏</PresentationFormat>
  <Paragraphs>17</Paragraphs>
  <Slides>1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1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8</cp:revision>
  <dcterms:created xsi:type="dcterms:W3CDTF">2022-03-12T04:49:51Z</dcterms:created>
  <dcterms:modified xsi:type="dcterms:W3CDTF">2022-03-12T05:11:55Z</dcterms:modified>
</cp:coreProperties>
</file>